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5E492-CBC7-40A2-A5F3-4090C9F56A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56FBB-5076-4DC2-AD58-66D0BBBF5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A7A829-C1C2-451A-A0EE-836EB0A401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3B922-7AD7-4C09-8D5E-9635A1262C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691EE-247D-4749-95EA-B49BDDFA0B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19C80-FBAB-4357-8874-F6FEC2B849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AA2F3-CB0E-48A9-9686-8A40FCBE4F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A6A62-B98F-4781-A6BA-D9E248B4AB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AE15F-940C-4998-A2BA-36AABE3DC2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F6A09-2C6A-4FFA-A2B2-4AD9DE33DA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818F3-7760-4132-B640-CBAC5BAA08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B5D50-E281-4A5B-BBFA-D5B7FB1308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F0EFC3-A333-409F-A982-CBF2F16FD1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36640" y="1325520"/>
            <a:ext cx="4686120" cy="5553720"/>
            <a:chOff x="836640" y="1325520"/>
            <a:chExt cx="4686120" cy="5553720"/>
          </a:xfrm>
        </p:grpSpPr>
        <p:sp>
          <p:nvSpPr>
            <p:cNvPr id="42" name=""/>
            <p:cNvSpPr/>
            <p:nvPr/>
          </p:nvSpPr>
          <p:spPr>
            <a:xfrm rot="16200000">
              <a:off x="-438120" y="3477600"/>
              <a:ext cx="2733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% Pair-wise distance from MSV-Mat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506600" y="6270840"/>
              <a:ext cx="3873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990800" y="6228000"/>
              <a:ext cx="144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959200" y="6228000"/>
              <a:ext cx="144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27600" y="6228000"/>
              <a:ext cx="144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896000" y="6228000"/>
              <a:ext cx="144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flipV="1">
              <a:off x="1506600" y="1480680"/>
              <a:ext cx="1440" cy="4789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302840" y="6153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H="1">
              <a:off x="1506240" y="507384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197720" y="49942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H="1">
              <a:off x="1506240" y="387684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197720" y="37972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>
              <a:off x="1506240" y="26798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197720" y="26020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H="1">
              <a:off x="1506240" y="148284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197720" y="14032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668600" y="5821560"/>
              <a:ext cx="512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637000" y="5791320"/>
              <a:ext cx="6444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605040" y="5791320"/>
              <a:ext cx="6447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573440" y="6031080"/>
              <a:ext cx="644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"/>
            <p:cNvGrpSpPr/>
            <p:nvPr/>
          </p:nvGrpSpPr>
          <p:grpSpPr>
            <a:xfrm>
              <a:off x="2855880" y="5477040"/>
              <a:ext cx="206280" cy="686880"/>
              <a:chOff x="2855880" y="5477040"/>
              <a:chExt cx="206280" cy="686880"/>
            </a:xfrm>
          </p:grpSpPr>
          <p:sp>
            <p:nvSpPr>
              <p:cNvPr id="63" name=""/>
              <p:cNvSpPr/>
              <p:nvPr/>
            </p:nvSpPr>
            <p:spPr>
              <a:xfrm>
                <a:off x="2933640" y="5597280"/>
                <a:ext cx="50760" cy="270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933640" y="5895720"/>
                <a:ext cx="50760" cy="288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933640" y="5956200"/>
                <a:ext cx="50760" cy="288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933640" y="6135480"/>
                <a:ext cx="50760" cy="2844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855880" y="5597280"/>
                <a:ext cx="52200" cy="270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011400" y="6135480"/>
                <a:ext cx="50760" cy="2844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011400" y="5895720"/>
                <a:ext cx="50760" cy="288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855880" y="5776560"/>
                <a:ext cx="52200" cy="270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933640" y="5477040"/>
                <a:ext cx="50760" cy="2844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933640" y="5716440"/>
                <a:ext cx="50760" cy="288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011400" y="5776560"/>
                <a:ext cx="50760" cy="270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933640" y="5776560"/>
                <a:ext cx="50760" cy="27000"/>
              </a:xfrm>
              <a:prstGeom prst="rect">
                <a:avLst/>
              </a:prstGeom>
              <a:solidFill>
                <a:srgbClr val="ff0000"/>
              </a:solidFill>
              <a:ln w="1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5" name=""/>
            <p:cNvGrpSpPr/>
            <p:nvPr/>
          </p:nvGrpSpPr>
          <p:grpSpPr>
            <a:xfrm>
              <a:off x="1809720" y="1706760"/>
              <a:ext cx="285480" cy="4396680"/>
              <a:chOff x="1809720" y="1706760"/>
              <a:chExt cx="285480" cy="4396680"/>
            </a:xfrm>
          </p:grpSpPr>
          <p:grpSp>
            <p:nvGrpSpPr>
              <p:cNvPr id="76" name=""/>
              <p:cNvGrpSpPr/>
              <p:nvPr/>
            </p:nvGrpSpPr>
            <p:grpSpPr>
              <a:xfrm>
                <a:off x="1870920" y="1706760"/>
                <a:ext cx="162360" cy="866160"/>
                <a:chOff x="1870920" y="1706760"/>
                <a:chExt cx="162360" cy="866160"/>
              </a:xfrm>
            </p:grpSpPr>
            <p:sp>
              <p:nvSpPr>
                <p:cNvPr id="77" name=""/>
                <p:cNvSpPr/>
                <p:nvPr/>
              </p:nvSpPr>
              <p:spPr>
                <a:xfrm>
                  <a:off x="1932120" y="170676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1993320" y="170676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1932120" y="254412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1870920" y="1825920"/>
                  <a:ext cx="4104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1932120" y="1946160"/>
                  <a:ext cx="3996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1932120" y="1825920"/>
                  <a:ext cx="3996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1932120" y="2065320"/>
                  <a:ext cx="39960" cy="270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4" name=""/>
              <p:cNvGrpSpPr/>
              <p:nvPr/>
            </p:nvGrpSpPr>
            <p:grpSpPr>
              <a:xfrm>
                <a:off x="1809720" y="5477040"/>
                <a:ext cx="285480" cy="626400"/>
                <a:chOff x="1809720" y="5477040"/>
                <a:chExt cx="285480" cy="626400"/>
              </a:xfrm>
            </p:grpSpPr>
            <p:sp>
              <p:nvSpPr>
                <p:cNvPr id="85" name=""/>
                <p:cNvSpPr/>
                <p:nvPr/>
              </p:nvSpPr>
              <p:spPr>
                <a:xfrm>
                  <a:off x="1932480" y="6075000"/>
                  <a:ext cx="3996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1870920" y="5776560"/>
                  <a:ext cx="41040" cy="270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1994040" y="6075000"/>
                  <a:ext cx="3996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1994040" y="595584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1870920" y="5895720"/>
                  <a:ext cx="4104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1932480" y="589572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1994040" y="571608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1809720" y="5895720"/>
                  <a:ext cx="4104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1994040" y="589572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1870920" y="5955840"/>
                  <a:ext cx="4104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1932480" y="5477040"/>
                  <a:ext cx="3996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1932480" y="595584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1870920" y="6075000"/>
                  <a:ext cx="41040" cy="2844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1932480" y="5776560"/>
                  <a:ext cx="39960" cy="270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1932480" y="571608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1932480" y="583668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1932480" y="601596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1870920" y="5716080"/>
                  <a:ext cx="4104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2055240" y="5895720"/>
                  <a:ext cx="39960" cy="28800"/>
                </a:xfrm>
                <a:prstGeom prst="ellipse">
                  <a:avLst/>
                </a:prstGeom>
                <a:solidFill>
                  <a:srgbClr val="008000"/>
                </a:solidFill>
                <a:ln w="14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4" name=""/>
            <p:cNvGrpSpPr/>
            <p:nvPr/>
          </p:nvGrpSpPr>
          <p:grpSpPr>
            <a:xfrm>
              <a:off x="3668760" y="4340160"/>
              <a:ext cx="439560" cy="1763640"/>
              <a:chOff x="3668760" y="4340160"/>
              <a:chExt cx="439560" cy="1763640"/>
            </a:xfrm>
          </p:grpSpPr>
          <p:sp>
            <p:nvSpPr>
              <p:cNvPr id="105" name=""/>
              <p:cNvSpPr/>
              <p:nvPr/>
            </p:nvSpPr>
            <p:spPr>
              <a:xfrm>
                <a:off x="3824280" y="5776560"/>
                <a:ext cx="52200" cy="27000"/>
              </a:xfrm>
              <a:custGeom>
                <a:avLst/>
                <a:gdLst/>
                <a:ahLst/>
                <a:rect l="l" t="t" r="r" b="b"/>
                <a:pathLst>
                  <a:path w="33" h="20">
                    <a:moveTo>
                      <a:pt x="0" y="20"/>
                    </a:moveTo>
                    <a:lnTo>
                      <a:pt x="33" y="20"/>
                    </a:lnTo>
                    <a:lnTo>
                      <a:pt x="16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902040" y="601632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824280" y="5896080"/>
                <a:ext cx="52200" cy="28800"/>
              </a:xfrm>
              <a:custGeom>
                <a:avLst/>
                <a:gdLst/>
                <a:ahLst/>
                <a:rect l="l" t="t" r="r" b="b"/>
                <a:pathLst>
                  <a:path w="33" h="21">
                    <a:moveTo>
                      <a:pt x="0" y="21"/>
                    </a:moveTo>
                    <a:lnTo>
                      <a:pt x="33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668760" y="5776560"/>
                <a:ext cx="52200" cy="27000"/>
              </a:xfrm>
              <a:custGeom>
                <a:avLst/>
                <a:gdLst/>
                <a:ahLst/>
                <a:rect l="l" t="t" r="r" b="b"/>
                <a:pathLst>
                  <a:path w="33" h="20">
                    <a:moveTo>
                      <a:pt x="0" y="20"/>
                    </a:moveTo>
                    <a:lnTo>
                      <a:pt x="33" y="20"/>
                    </a:lnTo>
                    <a:lnTo>
                      <a:pt x="17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902040" y="589608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902040" y="571644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902040" y="5597640"/>
                <a:ext cx="50760" cy="27000"/>
              </a:xfrm>
              <a:custGeom>
                <a:avLst/>
                <a:gdLst/>
                <a:ahLst/>
                <a:rect l="l" t="t" r="r" b="b"/>
                <a:pathLst>
                  <a:path w="32" h="20">
                    <a:moveTo>
                      <a:pt x="0" y="20"/>
                    </a:moveTo>
                    <a:lnTo>
                      <a:pt x="32" y="20"/>
                    </a:lnTo>
                    <a:lnTo>
                      <a:pt x="16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824280" y="6075360"/>
                <a:ext cx="52200" cy="28440"/>
              </a:xfrm>
              <a:custGeom>
                <a:avLst/>
                <a:gdLst/>
                <a:ahLst/>
                <a:rect l="l" t="t" r="r" b="b"/>
                <a:pathLst>
                  <a:path w="33" h="21">
                    <a:moveTo>
                      <a:pt x="0" y="21"/>
                    </a:moveTo>
                    <a:lnTo>
                      <a:pt x="33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979800" y="607536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902040" y="5418000"/>
                <a:ext cx="50760" cy="27000"/>
              </a:xfrm>
              <a:custGeom>
                <a:avLst/>
                <a:gdLst/>
                <a:ahLst/>
                <a:rect l="l" t="t" r="r" b="b"/>
                <a:pathLst>
                  <a:path w="32" h="20">
                    <a:moveTo>
                      <a:pt x="0" y="20"/>
                    </a:moveTo>
                    <a:lnTo>
                      <a:pt x="32" y="20"/>
                    </a:lnTo>
                    <a:lnTo>
                      <a:pt x="16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902040" y="5776560"/>
                <a:ext cx="50760" cy="27000"/>
              </a:xfrm>
              <a:custGeom>
                <a:avLst/>
                <a:gdLst/>
                <a:ahLst/>
                <a:rect l="l" t="t" r="r" b="b"/>
                <a:pathLst>
                  <a:path w="32" h="20">
                    <a:moveTo>
                      <a:pt x="0" y="20"/>
                    </a:moveTo>
                    <a:lnTo>
                      <a:pt x="32" y="20"/>
                    </a:lnTo>
                    <a:lnTo>
                      <a:pt x="16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979800" y="589608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979800" y="571644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746520" y="5776560"/>
                <a:ext cx="52200" cy="27000"/>
              </a:xfrm>
              <a:custGeom>
                <a:avLst/>
                <a:gdLst/>
                <a:ahLst/>
                <a:rect l="l" t="t" r="r" b="b"/>
                <a:pathLst>
                  <a:path w="33" h="20">
                    <a:moveTo>
                      <a:pt x="0" y="20"/>
                    </a:moveTo>
                    <a:lnTo>
                      <a:pt x="33" y="20"/>
                    </a:lnTo>
                    <a:lnTo>
                      <a:pt x="17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055760" y="5776560"/>
                <a:ext cx="52560" cy="27000"/>
              </a:xfrm>
              <a:custGeom>
                <a:avLst/>
                <a:gdLst/>
                <a:ahLst/>
                <a:rect l="l" t="t" r="r" b="b"/>
                <a:pathLst>
                  <a:path w="33" h="20">
                    <a:moveTo>
                      <a:pt x="0" y="20"/>
                    </a:moveTo>
                    <a:lnTo>
                      <a:pt x="33" y="20"/>
                    </a:lnTo>
                    <a:lnTo>
                      <a:pt x="17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902040" y="565776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902040" y="583704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902040" y="434016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979800" y="5776560"/>
                <a:ext cx="50760" cy="27000"/>
              </a:xfrm>
              <a:custGeom>
                <a:avLst/>
                <a:gdLst/>
                <a:ahLst/>
                <a:rect l="l" t="t" r="r" b="b"/>
                <a:pathLst>
                  <a:path w="32" h="20">
                    <a:moveTo>
                      <a:pt x="0" y="20"/>
                    </a:moveTo>
                    <a:lnTo>
                      <a:pt x="32" y="20"/>
                    </a:lnTo>
                    <a:lnTo>
                      <a:pt x="16" y="0"/>
                    </a:lnTo>
                    <a:lnTo>
                      <a:pt x="0" y="20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902040" y="439884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902040" y="595620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902040" y="607536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0" y="21"/>
                    </a:moveTo>
                    <a:lnTo>
                      <a:pt x="32" y="21"/>
                    </a:lnTo>
                    <a:lnTo>
                      <a:pt x="16" y="0"/>
                    </a:lnTo>
                    <a:lnTo>
                      <a:pt x="0" y="21"/>
                    </a:lnTo>
                    <a:close/>
                  </a:path>
                </a:pathLst>
              </a:custGeom>
              <a:solidFill>
                <a:srgbClr val="008000"/>
              </a:solidFill>
              <a:ln w="144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"/>
            <p:cNvGrpSpPr/>
            <p:nvPr/>
          </p:nvGrpSpPr>
          <p:grpSpPr>
            <a:xfrm>
              <a:off x="4792680" y="5776920"/>
              <a:ext cx="206280" cy="447480"/>
              <a:chOff x="4792680" y="5776920"/>
              <a:chExt cx="206280" cy="447480"/>
            </a:xfrm>
          </p:grpSpPr>
          <p:sp>
            <p:nvSpPr>
              <p:cNvPr id="128" name=""/>
              <p:cNvSpPr/>
              <p:nvPr/>
            </p:nvSpPr>
            <p:spPr>
              <a:xfrm>
                <a:off x="4870440" y="589608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792680" y="6016680"/>
                <a:ext cx="52200" cy="28800"/>
              </a:xfrm>
              <a:custGeom>
                <a:avLst/>
                <a:gdLst/>
                <a:ahLst/>
                <a:rect l="l" t="t" r="r" b="b"/>
                <a:pathLst>
                  <a:path w="33" h="21">
                    <a:moveTo>
                      <a:pt x="16" y="21"/>
                    </a:moveTo>
                    <a:lnTo>
                      <a:pt x="33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870440" y="619596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870440" y="613584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870440" y="5776920"/>
                <a:ext cx="50760" cy="27000"/>
              </a:xfrm>
              <a:custGeom>
                <a:avLst/>
                <a:gdLst/>
                <a:ahLst/>
                <a:rect l="l" t="t" r="r" b="b"/>
                <a:pathLst>
                  <a:path w="32" h="20">
                    <a:moveTo>
                      <a:pt x="16" y="20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0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870440" y="583704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870440" y="595620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792680" y="5896080"/>
                <a:ext cx="52200" cy="28800"/>
              </a:xfrm>
              <a:custGeom>
                <a:avLst/>
                <a:gdLst/>
                <a:ahLst/>
                <a:rect l="l" t="t" r="r" b="b"/>
                <a:pathLst>
                  <a:path w="33" h="21">
                    <a:moveTo>
                      <a:pt x="16" y="21"/>
                    </a:moveTo>
                    <a:lnTo>
                      <a:pt x="33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948200" y="595620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792680" y="6135840"/>
                <a:ext cx="52200" cy="28440"/>
              </a:xfrm>
              <a:custGeom>
                <a:avLst/>
                <a:gdLst/>
                <a:ahLst/>
                <a:rect l="l" t="t" r="r" b="b"/>
                <a:pathLst>
                  <a:path w="33" h="21">
                    <a:moveTo>
                      <a:pt x="16" y="21"/>
                    </a:moveTo>
                    <a:lnTo>
                      <a:pt x="33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948200" y="607572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870440" y="601668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948200" y="6016680"/>
                <a:ext cx="50760" cy="2880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870440" y="6075720"/>
                <a:ext cx="50760" cy="28440"/>
              </a:xfrm>
              <a:custGeom>
                <a:avLst/>
                <a:gdLst/>
                <a:ahLst/>
                <a:rect l="l" t="t" r="r" b="b"/>
                <a:pathLst>
                  <a:path w="32" h="21">
                    <a:moveTo>
                      <a:pt x="16" y="21"/>
                    </a:moveTo>
                    <a:lnTo>
                      <a:pt x="32" y="0"/>
                    </a:lnTo>
                    <a:lnTo>
                      <a:pt x="0" y="0"/>
                    </a:lnTo>
                    <a:lnTo>
                      <a:pt x="16" y="21"/>
                    </a:lnTo>
                    <a:close/>
                  </a:path>
                </a:pathLst>
              </a:custGeom>
              <a:solidFill>
                <a:srgbClr val="ff0000"/>
              </a:solidFill>
              <a:ln w="14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2" name=""/>
            <p:cNvSpPr/>
            <p:nvPr/>
          </p:nvSpPr>
          <p:spPr>
            <a:xfrm>
              <a:off x="2171880" y="5124600"/>
              <a:ext cx="730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5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157560" y="4692600"/>
              <a:ext cx="730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8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062240" y="4002120"/>
              <a:ext cx="79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0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728800" y="3279960"/>
              <a:ext cx="79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66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614760" y="2349720"/>
              <a:ext cx="79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0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143160" y="1325520"/>
              <a:ext cx="79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700" spc="-1" strike="noStrike">
                  <a:solidFill>
                    <a:srgbClr val="000000"/>
                  </a:solidFill>
                  <a:latin typeface="Arial"/>
                </a:rPr>
                <a:t>P= 0.0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685520" y="6346800"/>
              <a:ext cx="618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ensitive maiz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658240" y="6346800"/>
              <a:ext cx="627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esistant maiz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625560" y="6346800"/>
              <a:ext cx="618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ensitive maiz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593240" y="6346800"/>
              <a:ext cx="627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esistant maiz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720800" y="6478560"/>
              <a:ext cx="158292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atV1V2VW + VWV1V2M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800" spc="-1" strike="noStrike">
                  <a:solidFill>
                    <a:srgbClr val="000000"/>
                  </a:solidFill>
                  <a:latin typeface="Arial"/>
                </a:rPr>
                <a:t>recombinant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506760" y="6478560"/>
              <a:ext cx="201600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atV1V2LIRVW + VWV1V2LIRMa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ZA" sz="800" spc="-1" strike="noStrike">
                  <a:solidFill>
                    <a:srgbClr val="000000"/>
                  </a:solidFill>
                  <a:latin typeface="Arial"/>
                </a:rPr>
                <a:t>recombinant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4" name=""/>
            <p:cNvGrpSpPr/>
            <p:nvPr/>
          </p:nvGrpSpPr>
          <p:grpSpPr>
            <a:xfrm>
              <a:off x="1940040" y="5287680"/>
              <a:ext cx="1019160" cy="54360"/>
              <a:chOff x="1940040" y="5287680"/>
              <a:chExt cx="1019160" cy="54360"/>
            </a:xfrm>
          </p:grpSpPr>
          <p:sp>
            <p:nvSpPr>
              <p:cNvPr id="155" name=""/>
              <p:cNvSpPr/>
              <p:nvPr/>
            </p:nvSpPr>
            <p:spPr>
              <a:xfrm>
                <a:off x="1940040" y="5342040"/>
                <a:ext cx="101916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V="1">
                <a:off x="2419560" y="5287680"/>
                <a:ext cx="0" cy="5076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7" name=""/>
            <p:cNvSpPr/>
            <p:nvPr/>
          </p:nvSpPr>
          <p:spPr>
            <a:xfrm>
              <a:off x="2962440" y="2592360"/>
              <a:ext cx="1955520" cy="0"/>
            </a:xfrm>
            <a:prstGeom prst="line">
              <a:avLst/>
            </a:prstGeom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3940200" y="2538000"/>
              <a:ext cx="0" cy="50760"/>
            </a:xfrm>
            <a:prstGeom prst="line">
              <a:avLst/>
            </a:prstGeom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9" name=""/>
            <p:cNvGrpSpPr/>
            <p:nvPr/>
          </p:nvGrpSpPr>
          <p:grpSpPr>
            <a:xfrm>
              <a:off x="1990800" y="3476520"/>
              <a:ext cx="1963800" cy="54000"/>
              <a:chOff x="1990800" y="3476520"/>
              <a:chExt cx="1963800" cy="54000"/>
            </a:xfrm>
          </p:grpSpPr>
          <p:sp>
            <p:nvSpPr>
              <p:cNvPr id="160" name=""/>
              <p:cNvSpPr/>
              <p:nvPr/>
            </p:nvSpPr>
            <p:spPr>
              <a:xfrm>
                <a:off x="1990800" y="3530520"/>
                <a:ext cx="196380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V="1">
                <a:off x="2972160" y="3476520"/>
                <a:ext cx="0" cy="5112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2" name=""/>
            <p:cNvGrpSpPr/>
            <p:nvPr/>
          </p:nvGrpSpPr>
          <p:grpSpPr>
            <a:xfrm>
              <a:off x="3917880" y="4184280"/>
              <a:ext cx="1019160" cy="54360"/>
              <a:chOff x="3917880" y="4184280"/>
              <a:chExt cx="1019160" cy="54360"/>
            </a:xfrm>
          </p:grpSpPr>
          <p:sp>
            <p:nvSpPr>
              <p:cNvPr id="163" name=""/>
              <p:cNvSpPr/>
              <p:nvPr/>
            </p:nvSpPr>
            <p:spPr>
              <a:xfrm>
                <a:off x="3917880" y="4238640"/>
                <a:ext cx="101916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flipV="1">
                <a:off x="4397400" y="4184280"/>
                <a:ext cx="0" cy="5076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5" name=""/>
            <p:cNvGrpSpPr/>
            <p:nvPr/>
          </p:nvGrpSpPr>
          <p:grpSpPr>
            <a:xfrm>
              <a:off x="2921040" y="4885920"/>
              <a:ext cx="1019160" cy="54360"/>
              <a:chOff x="2921040" y="4885920"/>
              <a:chExt cx="1019160" cy="54360"/>
            </a:xfrm>
          </p:grpSpPr>
          <p:sp>
            <p:nvSpPr>
              <p:cNvPr id="166" name=""/>
              <p:cNvSpPr/>
              <p:nvPr/>
            </p:nvSpPr>
            <p:spPr>
              <a:xfrm>
                <a:off x="2921040" y="4940280"/>
                <a:ext cx="101916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 flipV="1">
                <a:off x="3400560" y="4885920"/>
                <a:ext cx="0" cy="5076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8" name=""/>
            <p:cNvGrpSpPr/>
            <p:nvPr/>
          </p:nvGrpSpPr>
          <p:grpSpPr>
            <a:xfrm>
              <a:off x="1981080" y="1526760"/>
              <a:ext cx="2948040" cy="54360"/>
              <a:chOff x="1981080" y="1526760"/>
              <a:chExt cx="2948040" cy="54360"/>
            </a:xfrm>
          </p:grpSpPr>
          <p:sp>
            <p:nvSpPr>
              <p:cNvPr id="169" name=""/>
              <p:cNvSpPr/>
              <p:nvPr/>
            </p:nvSpPr>
            <p:spPr>
              <a:xfrm>
                <a:off x="1981080" y="1581120"/>
                <a:ext cx="2948040" cy="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3454200" y="1526760"/>
                <a:ext cx="0" cy="50760"/>
              </a:xfrm>
              <a:prstGeom prst="line">
                <a:avLst/>
              </a:prstGeom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3T21:51:10Z</dcterms:created>
  <dc:creator> </dc:creator>
  <dc:description/>
  <dc:language>en-US</dc:language>
  <cp:lastModifiedBy>Aderito</cp:lastModifiedBy>
  <dcterms:modified xsi:type="dcterms:W3CDTF">2011-10-29T15:48:53Z</dcterms:modified>
  <cp:revision>20</cp:revision>
  <dc:subject/>
  <dc:title>Slide 1</dc:title>
</cp:coreProperties>
</file>